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88163" cy="100171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485" y="-1413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7505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0720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5702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2460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8826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5897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6945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263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1730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9238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2FF19-CFE9-49D5-9A7A-6B9810A7FD6A}" type="datetimeFigureOut">
              <a:rPr lang="es-ES" smtClean="0"/>
              <a:pPr/>
              <a:t>02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6734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ED22C25E-BD0B-C106-9936-A5E6C0D44660}"/>
              </a:ext>
            </a:extLst>
          </p:cNvPr>
          <p:cNvGrpSpPr/>
          <p:nvPr/>
        </p:nvGrpSpPr>
        <p:grpSpPr>
          <a:xfrm>
            <a:off x="546100" y="2023560"/>
            <a:ext cx="6129020" cy="5598326"/>
            <a:chOff x="546100" y="766260"/>
            <a:chExt cx="5894914" cy="5598326"/>
          </a:xfrm>
        </p:grpSpPr>
        <p:grpSp>
          <p:nvGrpSpPr>
            <p:cNvPr id="40" name="54 Grupo"/>
            <p:cNvGrpSpPr/>
            <p:nvPr/>
          </p:nvGrpSpPr>
          <p:grpSpPr>
            <a:xfrm>
              <a:off x="651333" y="1269698"/>
              <a:ext cx="2606052" cy="637002"/>
              <a:chOff x="916669" y="1927902"/>
              <a:chExt cx="2606052" cy="637002"/>
            </a:xfrm>
          </p:grpSpPr>
          <p:cxnSp>
            <p:nvCxnSpPr>
              <p:cNvPr id="47" name="46 Conector recto"/>
              <p:cNvCxnSpPr/>
              <p:nvPr/>
            </p:nvCxnSpPr>
            <p:spPr>
              <a:xfrm>
                <a:off x="1288685" y="2046040"/>
                <a:ext cx="93610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49 Conector recto"/>
              <p:cNvCxnSpPr/>
              <p:nvPr/>
            </p:nvCxnSpPr>
            <p:spPr>
              <a:xfrm>
                <a:off x="1297136" y="2118048"/>
                <a:ext cx="93610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55 CuadroTexto"/>
              <p:cNvSpPr txBox="1"/>
              <p:nvPr/>
            </p:nvSpPr>
            <p:spPr>
              <a:xfrm>
                <a:off x="916669" y="1927902"/>
                <a:ext cx="5676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900" dirty="0"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TGGC</a:t>
                </a:r>
                <a:endParaRPr lang="en-US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57" name="56 CuadroTexto"/>
              <p:cNvSpPr txBox="1"/>
              <p:nvPr/>
            </p:nvSpPr>
            <p:spPr>
              <a:xfrm>
                <a:off x="2158057" y="1999910"/>
                <a:ext cx="5676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900" dirty="0"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CAAA</a:t>
                </a:r>
                <a:endParaRPr lang="en-US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cxnSp>
            <p:nvCxnSpPr>
              <p:cNvPr id="60" name="59 Conector recto"/>
              <p:cNvCxnSpPr/>
              <p:nvPr/>
            </p:nvCxnSpPr>
            <p:spPr>
              <a:xfrm>
                <a:off x="1300311" y="2380202"/>
                <a:ext cx="936104" cy="0"/>
              </a:xfrm>
              <a:prstGeom prst="line">
                <a:avLst/>
              </a:prstGeom>
              <a:ln w="28575">
                <a:solidFill>
                  <a:schemeClr val="accent5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60 Conector recto"/>
              <p:cNvCxnSpPr/>
              <p:nvPr/>
            </p:nvCxnSpPr>
            <p:spPr>
              <a:xfrm>
                <a:off x="1308762" y="2452210"/>
                <a:ext cx="936104" cy="0"/>
              </a:xfrm>
              <a:prstGeom prst="line">
                <a:avLst/>
              </a:prstGeom>
              <a:ln w="28575">
                <a:solidFill>
                  <a:schemeClr val="accent5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61 CuadroTexto"/>
              <p:cNvSpPr txBox="1"/>
              <p:nvPr/>
            </p:nvSpPr>
            <p:spPr>
              <a:xfrm>
                <a:off x="928295" y="2262064"/>
                <a:ext cx="5676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900" dirty="0"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TGGC</a:t>
                </a:r>
                <a:endParaRPr lang="en-US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63" name="62 CuadroTexto"/>
              <p:cNvSpPr txBox="1"/>
              <p:nvPr/>
            </p:nvSpPr>
            <p:spPr>
              <a:xfrm>
                <a:off x="2169683" y="2334072"/>
                <a:ext cx="5676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900" dirty="0"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CAAA</a:t>
                </a:r>
                <a:endParaRPr lang="en-US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64" name="63 CuadroTexto"/>
              <p:cNvSpPr txBox="1"/>
              <p:nvPr/>
            </p:nvSpPr>
            <p:spPr>
              <a:xfrm>
                <a:off x="2487447" y="1945698"/>
                <a:ext cx="10081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050" b="1" dirty="0">
                    <a:solidFill>
                      <a:schemeClr val="accent1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gRNA1</a:t>
                </a:r>
                <a:endParaRPr lang="en-US" sz="1050" b="1" dirty="0">
                  <a:solidFill>
                    <a:schemeClr val="accent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65" name="64 CuadroTexto"/>
              <p:cNvSpPr txBox="1"/>
              <p:nvPr/>
            </p:nvSpPr>
            <p:spPr>
              <a:xfrm>
                <a:off x="2514609" y="2288486"/>
                <a:ext cx="10081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050" b="1" dirty="0">
                    <a:solidFill>
                      <a:schemeClr val="accent5">
                        <a:lumMod val="75000"/>
                      </a:schemeClr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gRNA2</a:t>
                </a:r>
                <a:endParaRPr lang="en-US" sz="1050" b="1" dirty="0">
                  <a:solidFill>
                    <a:schemeClr val="accent5">
                      <a:lumMod val="75000"/>
                    </a:schemeClr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</p:grpSp>
        <p:sp>
          <p:nvSpPr>
            <p:cNvPr id="66" name="65 CuadroTexto"/>
            <p:cNvSpPr txBox="1"/>
            <p:nvPr/>
          </p:nvSpPr>
          <p:spPr>
            <a:xfrm>
              <a:off x="743393" y="766260"/>
              <a:ext cx="40063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grpSp>
          <p:nvGrpSpPr>
            <p:cNvPr id="67" name="55 Grupo"/>
            <p:cNvGrpSpPr/>
            <p:nvPr/>
          </p:nvGrpSpPr>
          <p:grpSpPr>
            <a:xfrm>
              <a:off x="4252952" y="845943"/>
              <a:ext cx="2188062" cy="966722"/>
              <a:chOff x="4374272" y="1230059"/>
              <a:chExt cx="2188062" cy="966722"/>
            </a:xfrm>
          </p:grpSpPr>
          <p:sp>
            <p:nvSpPr>
              <p:cNvPr id="68" name="67 Rectángulo redondeado"/>
              <p:cNvSpPr/>
              <p:nvPr/>
            </p:nvSpPr>
            <p:spPr>
              <a:xfrm>
                <a:off x="4374272" y="1676333"/>
                <a:ext cx="1584000" cy="520448"/>
              </a:xfrm>
              <a:prstGeom prst="roundRect">
                <a:avLst/>
              </a:prstGeom>
              <a:noFill/>
              <a:ln w="79375"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9" name="68 CuadroTexto"/>
              <p:cNvSpPr txBox="1"/>
              <p:nvPr/>
            </p:nvSpPr>
            <p:spPr>
              <a:xfrm>
                <a:off x="4594518" y="1879933"/>
                <a:ext cx="19678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pYPQ131D/132D</a:t>
                </a:r>
                <a:endParaRPr lang="en-US" sz="1200" dirty="0"/>
              </a:p>
            </p:txBody>
          </p:sp>
          <p:sp>
            <p:nvSpPr>
              <p:cNvPr id="70" name="69 Flecha derecha"/>
              <p:cNvSpPr/>
              <p:nvPr/>
            </p:nvSpPr>
            <p:spPr>
              <a:xfrm>
                <a:off x="4734576" y="1445500"/>
                <a:ext cx="540000" cy="461665"/>
              </a:xfrm>
              <a:prstGeom prst="rightArrow">
                <a:avLst/>
              </a:prstGeom>
              <a:solidFill>
                <a:schemeClr val="bg1">
                  <a:lumMod val="50000"/>
                </a:schemeClr>
              </a:solidFill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1" name="70 CuadroTexto"/>
              <p:cNvSpPr txBox="1"/>
              <p:nvPr/>
            </p:nvSpPr>
            <p:spPr>
              <a:xfrm>
                <a:off x="4722214" y="1538999"/>
                <a:ext cx="6279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>
                    <a:solidFill>
                      <a:schemeClr val="bg1"/>
                    </a:solidFill>
                  </a:rPr>
                  <a:t>OsU3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72" name="71 Conector recto"/>
              <p:cNvCxnSpPr/>
              <p:nvPr/>
            </p:nvCxnSpPr>
            <p:spPr>
              <a:xfrm>
                <a:off x="5292080" y="1556792"/>
                <a:ext cx="0" cy="252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72 CuadroTexto"/>
              <p:cNvSpPr txBox="1"/>
              <p:nvPr/>
            </p:nvSpPr>
            <p:spPr>
              <a:xfrm>
                <a:off x="5067430" y="1303869"/>
                <a:ext cx="8007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dirty="0"/>
                  <a:t>BsmBI</a:t>
                </a:r>
                <a:endParaRPr lang="en-US" sz="1200" dirty="0"/>
              </a:p>
            </p:txBody>
          </p:sp>
          <p:cxnSp>
            <p:nvCxnSpPr>
              <p:cNvPr id="74" name="73 Conector recto"/>
              <p:cNvCxnSpPr/>
              <p:nvPr/>
            </p:nvCxnSpPr>
            <p:spPr>
              <a:xfrm>
                <a:off x="5427228" y="1556792"/>
                <a:ext cx="0" cy="252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74 Rectángulo"/>
              <p:cNvSpPr/>
              <p:nvPr/>
            </p:nvSpPr>
            <p:spPr>
              <a:xfrm>
                <a:off x="5456106" y="1556792"/>
                <a:ext cx="144000" cy="252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6" name="75 CuadroTexto"/>
              <p:cNvSpPr txBox="1"/>
              <p:nvPr/>
            </p:nvSpPr>
            <p:spPr>
              <a:xfrm>
                <a:off x="5403983" y="1530914"/>
                <a:ext cx="2966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T</a:t>
                </a:r>
                <a:endParaRPr lang="en-US" sz="1200" b="1" dirty="0"/>
              </a:p>
            </p:txBody>
          </p:sp>
          <p:pic>
            <p:nvPicPr>
              <p:cNvPr id="77" name="Picture 4" descr="C:\Users\mbundo\AppData\Local\Microsoft\Windows\Temporary Internet Files\Content.IE5\KU9IDDEE\scissors-silhouette[1]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5268095" y="1254922"/>
                <a:ext cx="182926" cy="133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78" name="77 CuadroTexto"/>
            <p:cNvSpPr txBox="1"/>
            <p:nvPr/>
          </p:nvSpPr>
          <p:spPr>
            <a:xfrm>
              <a:off x="3257644" y="4717752"/>
              <a:ext cx="1597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pYPQ167 (</a:t>
              </a:r>
              <a:r>
                <a:rPr lang="es-ES_tradnl" sz="1200" dirty="0"/>
                <a:t>7377 </a:t>
              </a:r>
              <a:r>
                <a:rPr lang="es-ES_tradnl" sz="1200" dirty="0" err="1"/>
                <a:t>bp</a:t>
              </a:r>
              <a:r>
                <a:rPr lang="es-ES_tradnl" sz="1200" dirty="0"/>
                <a:t>)</a:t>
              </a:r>
              <a:endParaRPr lang="en-US" sz="1200" dirty="0"/>
            </a:p>
          </p:txBody>
        </p:sp>
        <p:sp>
          <p:nvSpPr>
            <p:cNvPr id="79" name="78 Rectángulo redondeado"/>
            <p:cNvSpPr/>
            <p:nvPr/>
          </p:nvSpPr>
          <p:spPr>
            <a:xfrm>
              <a:off x="546100" y="5463528"/>
              <a:ext cx="5704526" cy="901058"/>
            </a:xfrm>
            <a:prstGeom prst="roundRect">
              <a:avLst/>
            </a:prstGeom>
            <a:noFill/>
            <a:ln w="79375"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0" name="79 CuadroTexto"/>
            <p:cNvSpPr txBox="1"/>
            <p:nvPr/>
          </p:nvSpPr>
          <p:spPr>
            <a:xfrm>
              <a:off x="2617388" y="5953015"/>
              <a:ext cx="21433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000" b="1" dirty="0"/>
                <a:t>pYPQ203-CRISPR-MIR827  (</a:t>
              </a:r>
              <a:r>
                <a:rPr lang="es-ES_tradnl" sz="1000" dirty="0"/>
                <a:t>12979 </a:t>
              </a:r>
              <a:r>
                <a:rPr lang="es-ES_tradnl" sz="1000" dirty="0" err="1"/>
                <a:t>bp</a:t>
              </a:r>
              <a:r>
                <a:rPr lang="es-ES_tradnl" sz="1000" dirty="0"/>
                <a:t>)</a:t>
              </a:r>
              <a:endParaRPr lang="en-US" sz="1000" dirty="0"/>
            </a:p>
          </p:txBody>
        </p:sp>
        <p:grpSp>
          <p:nvGrpSpPr>
            <p:cNvPr id="263" name="262 Grupo"/>
            <p:cNvGrpSpPr/>
            <p:nvPr/>
          </p:nvGrpSpPr>
          <p:grpSpPr>
            <a:xfrm>
              <a:off x="5491483" y="5329360"/>
              <a:ext cx="557802" cy="276999"/>
              <a:chOff x="5499601" y="5329360"/>
              <a:chExt cx="557802" cy="276999"/>
            </a:xfrm>
          </p:grpSpPr>
          <p:sp>
            <p:nvSpPr>
              <p:cNvPr id="93" name="92 Rectángulo"/>
              <p:cNvSpPr/>
              <p:nvPr/>
            </p:nvSpPr>
            <p:spPr>
              <a:xfrm>
                <a:off x="5581294" y="5342195"/>
                <a:ext cx="360000" cy="252000"/>
              </a:xfrm>
              <a:prstGeom prst="rect">
                <a:avLst/>
              </a:prstGeom>
              <a:pattFill prst="lgGrid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4" name="93 CuadroTexto"/>
              <p:cNvSpPr txBox="1"/>
              <p:nvPr/>
            </p:nvSpPr>
            <p:spPr>
              <a:xfrm>
                <a:off x="5499601" y="5329360"/>
                <a:ext cx="55780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attR2</a:t>
                </a:r>
                <a:endParaRPr lang="en-US" sz="1200" b="1" dirty="0"/>
              </a:p>
            </p:txBody>
          </p:sp>
        </p:grpSp>
        <p:grpSp>
          <p:nvGrpSpPr>
            <p:cNvPr id="262" name="261 Grupo"/>
            <p:cNvGrpSpPr/>
            <p:nvPr/>
          </p:nvGrpSpPr>
          <p:grpSpPr>
            <a:xfrm>
              <a:off x="1457367" y="5302622"/>
              <a:ext cx="589007" cy="252000"/>
              <a:chOff x="1513814" y="5289274"/>
              <a:chExt cx="589007" cy="276999"/>
            </a:xfrm>
          </p:grpSpPr>
          <p:sp>
            <p:nvSpPr>
              <p:cNvPr id="95" name="94 Rectángulo"/>
              <p:cNvSpPr/>
              <p:nvPr/>
            </p:nvSpPr>
            <p:spPr>
              <a:xfrm>
                <a:off x="1590950" y="5304264"/>
                <a:ext cx="360000" cy="252000"/>
              </a:xfrm>
              <a:prstGeom prst="rect">
                <a:avLst/>
              </a:prstGeom>
              <a:pattFill prst="pct70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6" name="95 CuadroTexto"/>
              <p:cNvSpPr txBox="1"/>
              <p:nvPr/>
            </p:nvSpPr>
            <p:spPr>
              <a:xfrm>
                <a:off x="1513814" y="5289274"/>
                <a:ext cx="5890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attR1</a:t>
                </a:r>
                <a:endParaRPr lang="en-US" sz="1200" b="1" dirty="0"/>
              </a:p>
            </p:txBody>
          </p:sp>
        </p:grpSp>
        <p:cxnSp>
          <p:nvCxnSpPr>
            <p:cNvPr id="97" name="96 Conector recto"/>
            <p:cNvCxnSpPr/>
            <p:nvPr/>
          </p:nvCxnSpPr>
          <p:spPr>
            <a:xfrm flipV="1">
              <a:off x="1533208" y="4978637"/>
              <a:ext cx="368303" cy="344773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97 Conector recto"/>
            <p:cNvCxnSpPr/>
            <p:nvPr/>
          </p:nvCxnSpPr>
          <p:spPr>
            <a:xfrm>
              <a:off x="1522158" y="4980856"/>
              <a:ext cx="372943" cy="331504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100 Flecha derecha"/>
            <p:cNvSpPr/>
            <p:nvPr/>
          </p:nvSpPr>
          <p:spPr>
            <a:xfrm>
              <a:off x="1010410" y="5210625"/>
              <a:ext cx="504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2" name="101 CuadroTexto"/>
            <p:cNvSpPr txBox="1"/>
            <p:nvPr/>
          </p:nvSpPr>
          <p:spPr>
            <a:xfrm>
              <a:off x="935810" y="5301546"/>
              <a:ext cx="639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ZmUbi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04" name="103 Conector recto"/>
            <p:cNvCxnSpPr/>
            <p:nvPr/>
          </p:nvCxnSpPr>
          <p:spPr>
            <a:xfrm>
              <a:off x="978609" y="4873151"/>
              <a:ext cx="2232000" cy="11941"/>
            </a:xfrm>
            <a:prstGeom prst="line">
              <a:avLst/>
            </a:prstGeom>
            <a:ln w="60325">
              <a:solidFill>
                <a:schemeClr val="bg2">
                  <a:lumMod val="9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104 Rectángulo"/>
            <p:cNvSpPr/>
            <p:nvPr/>
          </p:nvSpPr>
          <p:spPr>
            <a:xfrm>
              <a:off x="1937762" y="4757024"/>
              <a:ext cx="396000" cy="2520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6" name="105 CuadroTexto"/>
            <p:cNvSpPr txBox="1"/>
            <p:nvPr/>
          </p:nvSpPr>
          <p:spPr>
            <a:xfrm>
              <a:off x="1911885" y="4746593"/>
              <a:ext cx="7453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Cas9</a:t>
              </a:r>
              <a:endParaRPr lang="en-US" sz="1200" b="1" dirty="0"/>
            </a:p>
          </p:txBody>
        </p:sp>
        <p:grpSp>
          <p:nvGrpSpPr>
            <p:cNvPr id="261" name="260 Grupo"/>
            <p:cNvGrpSpPr/>
            <p:nvPr/>
          </p:nvGrpSpPr>
          <p:grpSpPr>
            <a:xfrm>
              <a:off x="1463674" y="4734093"/>
              <a:ext cx="508234" cy="252000"/>
              <a:chOff x="1503204" y="4734093"/>
              <a:chExt cx="508234" cy="276999"/>
            </a:xfrm>
          </p:grpSpPr>
          <p:sp>
            <p:nvSpPr>
              <p:cNvPr id="107" name="106 Rectángulo"/>
              <p:cNvSpPr/>
              <p:nvPr/>
            </p:nvSpPr>
            <p:spPr>
              <a:xfrm>
                <a:off x="1570631" y="4746593"/>
                <a:ext cx="360000" cy="252000"/>
              </a:xfrm>
              <a:prstGeom prst="rect">
                <a:avLst/>
              </a:prstGeom>
              <a:pattFill prst="pct70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8" name="107 CuadroTexto"/>
              <p:cNvSpPr txBox="1"/>
              <p:nvPr/>
            </p:nvSpPr>
            <p:spPr>
              <a:xfrm>
                <a:off x="1503204" y="4734093"/>
                <a:ext cx="5082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attL1</a:t>
                </a:r>
                <a:endParaRPr lang="en-US" sz="1200" b="1" dirty="0"/>
              </a:p>
            </p:txBody>
          </p:sp>
        </p:grpSp>
        <p:grpSp>
          <p:nvGrpSpPr>
            <p:cNvPr id="267" name="266 Grupo"/>
            <p:cNvGrpSpPr/>
            <p:nvPr/>
          </p:nvGrpSpPr>
          <p:grpSpPr>
            <a:xfrm>
              <a:off x="2434182" y="4734652"/>
              <a:ext cx="652250" cy="276999"/>
              <a:chOff x="2370633" y="4734652"/>
              <a:chExt cx="652250" cy="276999"/>
            </a:xfrm>
          </p:grpSpPr>
          <p:sp>
            <p:nvSpPr>
              <p:cNvPr id="109" name="108 Rectángulo"/>
              <p:cNvSpPr/>
              <p:nvPr/>
            </p:nvSpPr>
            <p:spPr>
              <a:xfrm>
                <a:off x="2456765" y="4744726"/>
                <a:ext cx="360000" cy="252000"/>
              </a:xfrm>
              <a:prstGeom prst="rect">
                <a:avLst/>
              </a:prstGeom>
              <a:pattFill prst="wdDnDiag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0" name="109 CuadroTexto"/>
              <p:cNvSpPr txBox="1"/>
              <p:nvPr/>
            </p:nvSpPr>
            <p:spPr>
              <a:xfrm>
                <a:off x="2370633" y="4734652"/>
                <a:ext cx="6522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attR5</a:t>
                </a:r>
                <a:endParaRPr lang="en-US" sz="1200" b="1" dirty="0"/>
              </a:p>
            </p:txBody>
          </p:sp>
        </p:grpSp>
        <p:sp>
          <p:nvSpPr>
            <p:cNvPr id="111" name="110 Rectángulo"/>
            <p:cNvSpPr/>
            <p:nvPr/>
          </p:nvSpPr>
          <p:spPr>
            <a:xfrm>
              <a:off x="2346729" y="4755137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2" name="111 CuadroTexto"/>
            <p:cNvSpPr txBox="1"/>
            <p:nvPr/>
          </p:nvSpPr>
          <p:spPr>
            <a:xfrm>
              <a:off x="2290788" y="4733998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grpSp>
          <p:nvGrpSpPr>
            <p:cNvPr id="116" name="13 Grupo"/>
            <p:cNvGrpSpPr/>
            <p:nvPr/>
          </p:nvGrpSpPr>
          <p:grpSpPr>
            <a:xfrm>
              <a:off x="5908087" y="5333234"/>
              <a:ext cx="360000" cy="276999"/>
              <a:chOff x="6190809" y="6453336"/>
              <a:chExt cx="443020" cy="276999"/>
            </a:xfrm>
          </p:grpSpPr>
          <p:sp>
            <p:nvSpPr>
              <p:cNvPr id="117" name="116 Rectángulo"/>
              <p:cNvSpPr/>
              <p:nvPr/>
            </p:nvSpPr>
            <p:spPr>
              <a:xfrm>
                <a:off x="6275310" y="6458852"/>
                <a:ext cx="226642" cy="252000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8" name="117 CuadroTexto"/>
              <p:cNvSpPr txBox="1"/>
              <p:nvPr/>
            </p:nvSpPr>
            <p:spPr>
              <a:xfrm>
                <a:off x="6190809" y="6453336"/>
                <a:ext cx="4430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>
                    <a:solidFill>
                      <a:schemeClr val="bg1"/>
                    </a:solidFill>
                  </a:rPr>
                  <a:t>LB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279" name="278 Grupo"/>
            <p:cNvGrpSpPr/>
            <p:nvPr/>
          </p:nvGrpSpPr>
          <p:grpSpPr>
            <a:xfrm>
              <a:off x="637602" y="5316738"/>
              <a:ext cx="443020" cy="260853"/>
              <a:chOff x="637602" y="5316738"/>
              <a:chExt cx="443020" cy="260853"/>
            </a:xfrm>
          </p:grpSpPr>
          <p:sp>
            <p:nvSpPr>
              <p:cNvPr id="119" name="118 Rectángulo"/>
              <p:cNvSpPr/>
              <p:nvPr/>
            </p:nvSpPr>
            <p:spPr>
              <a:xfrm>
                <a:off x="712228" y="5325591"/>
                <a:ext cx="216000" cy="252000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0" name="119 CuadroTexto"/>
              <p:cNvSpPr txBox="1"/>
              <p:nvPr/>
            </p:nvSpPr>
            <p:spPr>
              <a:xfrm>
                <a:off x="637602" y="5316738"/>
                <a:ext cx="44302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>
                    <a:solidFill>
                      <a:schemeClr val="bg1"/>
                    </a:solidFill>
                  </a:rPr>
                  <a:t>RB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28" name="127 Rectángulo redondeado"/>
            <p:cNvSpPr/>
            <p:nvPr/>
          </p:nvSpPr>
          <p:spPr>
            <a:xfrm>
              <a:off x="1349900" y="2562453"/>
              <a:ext cx="1584000" cy="530451"/>
            </a:xfrm>
            <a:prstGeom prst="roundRect">
              <a:avLst/>
            </a:prstGeom>
            <a:noFill/>
            <a:ln w="79375"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9" name="128 CuadroTexto"/>
            <p:cNvSpPr txBox="1"/>
            <p:nvPr/>
          </p:nvSpPr>
          <p:spPr>
            <a:xfrm>
              <a:off x="1407790" y="2776057"/>
              <a:ext cx="16062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pYPQ131D</a:t>
              </a:r>
              <a:r>
                <a:rPr lang="es-ES_tradnl" sz="1200" dirty="0"/>
                <a:t> (3087 </a:t>
              </a:r>
              <a:r>
                <a:rPr lang="es-ES_tradnl" sz="1200" dirty="0" err="1"/>
                <a:t>bp</a:t>
              </a:r>
              <a:r>
                <a:rPr lang="es-ES_tradnl" sz="1200" dirty="0"/>
                <a:t>)</a:t>
              </a:r>
              <a:endParaRPr lang="en-US" sz="1200" dirty="0"/>
            </a:p>
          </p:txBody>
        </p:sp>
        <p:sp>
          <p:nvSpPr>
            <p:cNvPr id="130" name="129 Flecha derecha"/>
            <p:cNvSpPr/>
            <p:nvPr/>
          </p:nvSpPr>
          <p:spPr>
            <a:xfrm>
              <a:off x="1536558" y="2336147"/>
              <a:ext cx="540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1" name="130 CuadroTexto"/>
            <p:cNvSpPr txBox="1"/>
            <p:nvPr/>
          </p:nvSpPr>
          <p:spPr>
            <a:xfrm>
              <a:off x="1526327" y="2428067"/>
              <a:ext cx="579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OsU3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32" name="131 Rectángulo"/>
            <p:cNvSpPr/>
            <p:nvPr/>
          </p:nvSpPr>
          <p:spPr>
            <a:xfrm>
              <a:off x="2591495" y="2435741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3" name="132 CuadroTexto"/>
            <p:cNvSpPr txBox="1"/>
            <p:nvPr/>
          </p:nvSpPr>
          <p:spPr>
            <a:xfrm>
              <a:off x="2536561" y="2418436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sp>
          <p:nvSpPr>
            <p:cNvPr id="134" name="133 Rectángulo"/>
            <p:cNvSpPr/>
            <p:nvPr/>
          </p:nvSpPr>
          <p:spPr>
            <a:xfrm>
              <a:off x="2074241" y="2435741"/>
              <a:ext cx="504000" cy="252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5" name="134 CuadroTexto"/>
            <p:cNvSpPr txBox="1"/>
            <p:nvPr/>
          </p:nvSpPr>
          <p:spPr>
            <a:xfrm>
              <a:off x="2033910" y="2428734"/>
              <a:ext cx="6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gRNA1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36" name="135 Conector recto"/>
            <p:cNvCxnSpPr/>
            <p:nvPr/>
          </p:nvCxnSpPr>
          <p:spPr>
            <a:xfrm>
              <a:off x="2785744" y="2438084"/>
              <a:ext cx="0" cy="25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136 Conector recto"/>
            <p:cNvCxnSpPr/>
            <p:nvPr/>
          </p:nvCxnSpPr>
          <p:spPr>
            <a:xfrm>
              <a:off x="1484343" y="2436693"/>
              <a:ext cx="0" cy="25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137 CuadroTexto"/>
            <p:cNvSpPr txBox="1"/>
            <p:nvPr/>
          </p:nvSpPr>
          <p:spPr>
            <a:xfrm>
              <a:off x="1267301" y="2213445"/>
              <a:ext cx="800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/>
                <a:t>BsaI</a:t>
              </a:r>
              <a:endParaRPr lang="en-US" sz="1200" dirty="0"/>
            </a:p>
          </p:txBody>
        </p:sp>
        <p:sp>
          <p:nvSpPr>
            <p:cNvPr id="139" name="138 CuadroTexto"/>
            <p:cNvSpPr txBox="1"/>
            <p:nvPr/>
          </p:nvSpPr>
          <p:spPr>
            <a:xfrm>
              <a:off x="2559678" y="2213445"/>
              <a:ext cx="800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/>
                <a:t>BsaI</a:t>
              </a:r>
              <a:endParaRPr lang="en-US" sz="1200" dirty="0"/>
            </a:p>
          </p:txBody>
        </p:sp>
        <p:pic>
          <p:nvPicPr>
            <p:cNvPr id="140" name="Picture 4" descr="C:\Users\mbundo\AppData\Local\Microsoft\Windows\Temporary Internet Files\Content.IE5\KU9IDDEE\scissors-silhouette[1]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401506" y="2123369"/>
              <a:ext cx="186289" cy="1356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1" name="Picture 4" descr="C:\Users\mbundo\AppData\Local\Microsoft\Windows\Temporary Internet Files\Content.IE5\KU9IDDEE\scissors-silhouette[1]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2703934" y="2125286"/>
              <a:ext cx="180232" cy="1312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0" name="62 Grupo"/>
            <p:cNvGrpSpPr/>
            <p:nvPr/>
          </p:nvGrpSpPr>
          <p:grpSpPr>
            <a:xfrm>
              <a:off x="3008702" y="1484784"/>
              <a:ext cx="439473" cy="780848"/>
              <a:chOff x="5650302" y="1552440"/>
              <a:chExt cx="439473" cy="780848"/>
            </a:xfrm>
          </p:grpSpPr>
          <p:sp>
            <p:nvSpPr>
              <p:cNvPr id="161" name="160 Forma libre"/>
              <p:cNvSpPr/>
              <p:nvPr/>
            </p:nvSpPr>
            <p:spPr>
              <a:xfrm>
                <a:off x="5650302" y="1552440"/>
                <a:ext cx="439473" cy="690427"/>
              </a:xfrm>
              <a:custGeom>
                <a:avLst/>
                <a:gdLst>
                  <a:gd name="connsiteX0" fmla="*/ 0 w 439473"/>
                  <a:gd name="connsiteY0" fmla="*/ 0 h 750498"/>
                  <a:gd name="connsiteX1" fmla="*/ 431321 w 439473"/>
                  <a:gd name="connsiteY1" fmla="*/ 345056 h 750498"/>
                  <a:gd name="connsiteX2" fmla="*/ 293298 w 439473"/>
                  <a:gd name="connsiteY2" fmla="*/ 750498 h 750498"/>
                  <a:gd name="connsiteX3" fmla="*/ 293298 w 439473"/>
                  <a:gd name="connsiteY3" fmla="*/ 750498 h 750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39473" h="750498">
                    <a:moveTo>
                      <a:pt x="0" y="0"/>
                    </a:moveTo>
                    <a:cubicBezTo>
                      <a:pt x="191219" y="109986"/>
                      <a:pt x="382438" y="219973"/>
                      <a:pt x="431321" y="345056"/>
                    </a:cubicBezTo>
                    <a:cubicBezTo>
                      <a:pt x="480204" y="470139"/>
                      <a:pt x="293298" y="750498"/>
                      <a:pt x="293298" y="750498"/>
                    </a:cubicBezTo>
                    <a:lnTo>
                      <a:pt x="293298" y="750498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2" name="161 Triángulo isósceles"/>
              <p:cNvSpPr/>
              <p:nvPr/>
            </p:nvSpPr>
            <p:spPr>
              <a:xfrm rot="12994844">
                <a:off x="5870038" y="2244535"/>
                <a:ext cx="91038" cy="88753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63" name="169 Grupo"/>
            <p:cNvGrpSpPr/>
            <p:nvPr/>
          </p:nvGrpSpPr>
          <p:grpSpPr>
            <a:xfrm flipH="1">
              <a:off x="3466361" y="1498704"/>
              <a:ext cx="439473" cy="780848"/>
              <a:chOff x="5650302" y="1552440"/>
              <a:chExt cx="439473" cy="780848"/>
            </a:xfrm>
          </p:grpSpPr>
          <p:sp>
            <p:nvSpPr>
              <p:cNvPr id="164" name="163 Forma libre"/>
              <p:cNvSpPr/>
              <p:nvPr/>
            </p:nvSpPr>
            <p:spPr>
              <a:xfrm>
                <a:off x="5650302" y="1552440"/>
                <a:ext cx="439473" cy="690427"/>
              </a:xfrm>
              <a:custGeom>
                <a:avLst/>
                <a:gdLst>
                  <a:gd name="connsiteX0" fmla="*/ 0 w 439473"/>
                  <a:gd name="connsiteY0" fmla="*/ 0 h 750498"/>
                  <a:gd name="connsiteX1" fmla="*/ 431321 w 439473"/>
                  <a:gd name="connsiteY1" fmla="*/ 345056 h 750498"/>
                  <a:gd name="connsiteX2" fmla="*/ 293298 w 439473"/>
                  <a:gd name="connsiteY2" fmla="*/ 750498 h 750498"/>
                  <a:gd name="connsiteX3" fmla="*/ 293298 w 439473"/>
                  <a:gd name="connsiteY3" fmla="*/ 750498 h 750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39473" h="750498">
                    <a:moveTo>
                      <a:pt x="0" y="0"/>
                    </a:moveTo>
                    <a:cubicBezTo>
                      <a:pt x="191219" y="109986"/>
                      <a:pt x="382438" y="219973"/>
                      <a:pt x="431321" y="345056"/>
                    </a:cubicBezTo>
                    <a:cubicBezTo>
                      <a:pt x="480204" y="470139"/>
                      <a:pt x="293298" y="750498"/>
                      <a:pt x="293298" y="750498"/>
                    </a:cubicBezTo>
                    <a:lnTo>
                      <a:pt x="293298" y="750498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5" name="164 Triángulo isósceles"/>
              <p:cNvSpPr/>
              <p:nvPr/>
            </p:nvSpPr>
            <p:spPr>
              <a:xfrm rot="12994844">
                <a:off x="5870038" y="2244535"/>
                <a:ext cx="91038" cy="88753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66" name="7 Grupo"/>
            <p:cNvGrpSpPr/>
            <p:nvPr/>
          </p:nvGrpSpPr>
          <p:grpSpPr>
            <a:xfrm>
              <a:off x="3336956" y="2844984"/>
              <a:ext cx="303623" cy="681884"/>
              <a:chOff x="5978556" y="2844984"/>
              <a:chExt cx="303623" cy="681884"/>
            </a:xfrm>
          </p:grpSpPr>
          <p:sp>
            <p:nvSpPr>
              <p:cNvPr id="167" name="166 Triángulo isósceles"/>
              <p:cNvSpPr/>
              <p:nvPr/>
            </p:nvSpPr>
            <p:spPr>
              <a:xfrm rot="10800000">
                <a:off x="6072959" y="3438115"/>
                <a:ext cx="91038" cy="88753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8" name="167 Forma libre"/>
              <p:cNvSpPr/>
              <p:nvPr/>
            </p:nvSpPr>
            <p:spPr>
              <a:xfrm>
                <a:off x="5978556" y="2844984"/>
                <a:ext cx="141344" cy="582027"/>
              </a:xfrm>
              <a:custGeom>
                <a:avLst/>
                <a:gdLst>
                  <a:gd name="connsiteX0" fmla="*/ 0 w 176459"/>
                  <a:gd name="connsiteY0" fmla="*/ 0 h 588396"/>
                  <a:gd name="connsiteX1" fmla="*/ 151075 w 176459"/>
                  <a:gd name="connsiteY1" fmla="*/ 190831 h 588396"/>
                  <a:gd name="connsiteX2" fmla="*/ 174929 w 176459"/>
                  <a:gd name="connsiteY2" fmla="*/ 588396 h 58839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76459" h="588396">
                    <a:moveTo>
                      <a:pt x="0" y="0"/>
                    </a:moveTo>
                    <a:cubicBezTo>
                      <a:pt x="60960" y="46382"/>
                      <a:pt x="121920" y="92765"/>
                      <a:pt x="151075" y="190831"/>
                    </a:cubicBezTo>
                    <a:cubicBezTo>
                      <a:pt x="180230" y="288897"/>
                      <a:pt x="177579" y="438646"/>
                      <a:pt x="174929" y="588396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9" name="168 Forma libre"/>
              <p:cNvSpPr/>
              <p:nvPr/>
            </p:nvSpPr>
            <p:spPr>
              <a:xfrm flipH="1">
                <a:off x="6116405" y="2844985"/>
                <a:ext cx="165774" cy="588396"/>
              </a:xfrm>
              <a:custGeom>
                <a:avLst/>
                <a:gdLst>
                  <a:gd name="connsiteX0" fmla="*/ 0 w 176459"/>
                  <a:gd name="connsiteY0" fmla="*/ 0 h 588396"/>
                  <a:gd name="connsiteX1" fmla="*/ 151075 w 176459"/>
                  <a:gd name="connsiteY1" fmla="*/ 190831 h 588396"/>
                  <a:gd name="connsiteX2" fmla="*/ 174929 w 176459"/>
                  <a:gd name="connsiteY2" fmla="*/ 588396 h 58839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76459" h="588396">
                    <a:moveTo>
                      <a:pt x="0" y="0"/>
                    </a:moveTo>
                    <a:cubicBezTo>
                      <a:pt x="60960" y="46382"/>
                      <a:pt x="121920" y="92765"/>
                      <a:pt x="151075" y="190831"/>
                    </a:cubicBezTo>
                    <a:cubicBezTo>
                      <a:pt x="180230" y="288897"/>
                      <a:pt x="177579" y="438646"/>
                      <a:pt x="174929" y="588396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79" name="178 Rectángulo redondeado"/>
            <p:cNvSpPr/>
            <p:nvPr/>
          </p:nvSpPr>
          <p:spPr>
            <a:xfrm>
              <a:off x="2048719" y="3807344"/>
              <a:ext cx="4074290" cy="635285"/>
            </a:xfrm>
            <a:prstGeom prst="roundRect">
              <a:avLst/>
            </a:prstGeom>
            <a:noFill/>
            <a:ln w="79375"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dirty="0"/>
                <a:t> </a:t>
              </a:r>
              <a:endParaRPr lang="en-US" dirty="0"/>
            </a:p>
          </p:txBody>
        </p:sp>
        <p:sp>
          <p:nvSpPr>
            <p:cNvPr id="180" name="179 CuadroTexto"/>
            <p:cNvSpPr txBox="1"/>
            <p:nvPr/>
          </p:nvSpPr>
          <p:spPr>
            <a:xfrm>
              <a:off x="3274775" y="4058556"/>
              <a:ext cx="1833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1200" b="1" dirty="0"/>
                <a:t>pYPQ142 (</a:t>
              </a:r>
              <a:r>
                <a:rPr lang="es-ES_tradnl" sz="1200" dirty="0"/>
                <a:t>3313 </a:t>
              </a:r>
              <a:r>
                <a:rPr lang="es-ES_tradnl" sz="1200" dirty="0" err="1"/>
                <a:t>bp</a:t>
              </a:r>
              <a:r>
                <a:rPr lang="es-ES_tradnl" sz="1200" dirty="0"/>
                <a:t>)</a:t>
              </a:r>
              <a:endParaRPr lang="en-US" sz="1200" dirty="0"/>
            </a:p>
          </p:txBody>
        </p:sp>
        <p:grpSp>
          <p:nvGrpSpPr>
            <p:cNvPr id="264" name="263 Grupo"/>
            <p:cNvGrpSpPr/>
            <p:nvPr/>
          </p:nvGrpSpPr>
          <p:grpSpPr>
            <a:xfrm>
              <a:off x="5508168" y="3665067"/>
              <a:ext cx="557802" cy="276999"/>
              <a:chOff x="5516735" y="3665067"/>
              <a:chExt cx="557802" cy="276999"/>
            </a:xfrm>
          </p:grpSpPr>
          <p:sp>
            <p:nvSpPr>
              <p:cNvPr id="195" name="194 Rectángulo"/>
              <p:cNvSpPr/>
              <p:nvPr/>
            </p:nvSpPr>
            <p:spPr>
              <a:xfrm>
                <a:off x="5589374" y="3686011"/>
                <a:ext cx="360000" cy="252000"/>
              </a:xfrm>
              <a:prstGeom prst="rect">
                <a:avLst/>
              </a:prstGeom>
              <a:pattFill prst="lgGrid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96" name="195 CuadroTexto"/>
              <p:cNvSpPr txBox="1"/>
              <p:nvPr/>
            </p:nvSpPr>
            <p:spPr>
              <a:xfrm>
                <a:off x="5516735" y="3665067"/>
                <a:ext cx="55780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attL2</a:t>
                </a:r>
                <a:endParaRPr lang="en-US" sz="1200" b="1" dirty="0"/>
              </a:p>
            </p:txBody>
          </p:sp>
        </p:grpSp>
        <p:cxnSp>
          <p:nvCxnSpPr>
            <p:cNvPr id="198" name="197 Conector recto"/>
            <p:cNvCxnSpPr/>
            <p:nvPr/>
          </p:nvCxnSpPr>
          <p:spPr>
            <a:xfrm>
              <a:off x="2513920" y="3947666"/>
              <a:ext cx="369029" cy="802134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198 Conector recto"/>
            <p:cNvCxnSpPr/>
            <p:nvPr/>
          </p:nvCxnSpPr>
          <p:spPr>
            <a:xfrm flipV="1">
              <a:off x="2522208" y="3936616"/>
              <a:ext cx="350842" cy="814950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199 Conector recto"/>
            <p:cNvCxnSpPr/>
            <p:nvPr/>
          </p:nvCxnSpPr>
          <p:spPr>
            <a:xfrm>
              <a:off x="5575396" y="3926981"/>
              <a:ext cx="358192" cy="1415918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200 Conector recto"/>
            <p:cNvCxnSpPr/>
            <p:nvPr/>
          </p:nvCxnSpPr>
          <p:spPr>
            <a:xfrm flipH="1">
              <a:off x="5586030" y="3926436"/>
              <a:ext cx="356237" cy="1404184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201 Rectángulo redondeado"/>
            <p:cNvSpPr/>
            <p:nvPr/>
          </p:nvSpPr>
          <p:spPr>
            <a:xfrm>
              <a:off x="4046355" y="2569989"/>
              <a:ext cx="1584000" cy="530451"/>
            </a:xfrm>
            <a:prstGeom prst="roundRect">
              <a:avLst/>
            </a:prstGeom>
            <a:noFill/>
            <a:ln w="79375"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3" name="202 CuadroTexto"/>
            <p:cNvSpPr txBox="1"/>
            <p:nvPr/>
          </p:nvSpPr>
          <p:spPr>
            <a:xfrm>
              <a:off x="4109077" y="2783593"/>
              <a:ext cx="16062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pYPQ132D</a:t>
              </a:r>
              <a:r>
                <a:rPr lang="es-ES_tradnl" sz="1200" dirty="0"/>
                <a:t> (3111 </a:t>
              </a:r>
              <a:r>
                <a:rPr lang="es-ES_tradnl" sz="1200" dirty="0" err="1"/>
                <a:t>bp</a:t>
              </a:r>
              <a:r>
                <a:rPr lang="es-ES_tradnl" sz="1200" dirty="0"/>
                <a:t>)</a:t>
              </a:r>
              <a:endParaRPr lang="en-US" sz="1200" dirty="0"/>
            </a:p>
          </p:txBody>
        </p:sp>
        <p:sp>
          <p:nvSpPr>
            <p:cNvPr id="204" name="203 Flecha derecha"/>
            <p:cNvSpPr/>
            <p:nvPr/>
          </p:nvSpPr>
          <p:spPr>
            <a:xfrm>
              <a:off x="4217109" y="2343683"/>
              <a:ext cx="540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5" name="204 CuadroTexto"/>
            <p:cNvSpPr txBox="1"/>
            <p:nvPr/>
          </p:nvSpPr>
          <p:spPr>
            <a:xfrm>
              <a:off x="4206878" y="2435603"/>
              <a:ext cx="579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OsU3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06" name="205 Rectángulo"/>
            <p:cNvSpPr/>
            <p:nvPr/>
          </p:nvSpPr>
          <p:spPr>
            <a:xfrm>
              <a:off x="5276022" y="2443277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7" name="206 CuadroTexto"/>
            <p:cNvSpPr txBox="1"/>
            <p:nvPr/>
          </p:nvSpPr>
          <p:spPr>
            <a:xfrm>
              <a:off x="5221088" y="2425972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sp>
          <p:nvSpPr>
            <p:cNvPr id="208" name="207 Rectángulo"/>
            <p:cNvSpPr/>
            <p:nvPr/>
          </p:nvSpPr>
          <p:spPr>
            <a:xfrm>
              <a:off x="4762744" y="2443277"/>
              <a:ext cx="504000" cy="252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9" name="208 CuadroTexto"/>
            <p:cNvSpPr txBox="1"/>
            <p:nvPr/>
          </p:nvSpPr>
          <p:spPr>
            <a:xfrm>
              <a:off x="4726389" y="2436270"/>
              <a:ext cx="7453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gRNA2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10" name="209 Conector recto"/>
            <p:cNvCxnSpPr/>
            <p:nvPr/>
          </p:nvCxnSpPr>
          <p:spPr>
            <a:xfrm>
              <a:off x="5450391" y="2445620"/>
              <a:ext cx="0" cy="25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210 Conector recto"/>
            <p:cNvCxnSpPr/>
            <p:nvPr/>
          </p:nvCxnSpPr>
          <p:spPr>
            <a:xfrm>
              <a:off x="4172846" y="2444229"/>
              <a:ext cx="0" cy="25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211 CuadroTexto"/>
            <p:cNvSpPr txBox="1"/>
            <p:nvPr/>
          </p:nvSpPr>
          <p:spPr>
            <a:xfrm>
              <a:off x="3955804" y="2220981"/>
              <a:ext cx="800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/>
                <a:t>BsaI</a:t>
              </a:r>
              <a:endParaRPr lang="en-US" sz="1200" dirty="0"/>
            </a:p>
          </p:txBody>
        </p:sp>
        <p:pic>
          <p:nvPicPr>
            <p:cNvPr id="213" name="Picture 4" descr="C:\Users\mbundo\AppData\Local\Microsoft\Windows\Temporary Internet Files\Content.IE5\KU9IDDEE\scissors-silhouette[1]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4090009" y="2130905"/>
              <a:ext cx="186289" cy="1356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4" name="Picture 4" descr="C:\Users\mbundo\AppData\Local\Microsoft\Windows\Temporary Internet Files\Content.IE5\KU9IDDEE\scissors-silhouette[1]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5396413" y="2132822"/>
              <a:ext cx="180232" cy="1312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5" name="214 CuadroTexto"/>
            <p:cNvSpPr txBox="1"/>
            <p:nvPr/>
          </p:nvSpPr>
          <p:spPr>
            <a:xfrm>
              <a:off x="5251846" y="2214939"/>
              <a:ext cx="800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/>
                <a:t>BsaI</a:t>
              </a:r>
              <a:endParaRPr lang="en-US" sz="1200" dirty="0"/>
            </a:p>
          </p:txBody>
        </p:sp>
        <p:sp>
          <p:nvSpPr>
            <p:cNvPr id="216" name="215 Flecha derecha"/>
            <p:cNvSpPr/>
            <p:nvPr/>
          </p:nvSpPr>
          <p:spPr>
            <a:xfrm>
              <a:off x="2965120" y="3569925"/>
              <a:ext cx="540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7" name="216 CuadroTexto"/>
            <p:cNvSpPr txBox="1"/>
            <p:nvPr/>
          </p:nvSpPr>
          <p:spPr>
            <a:xfrm>
              <a:off x="2954889" y="3661845"/>
              <a:ext cx="579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OsU3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18" name="217 Rectángulo"/>
            <p:cNvSpPr/>
            <p:nvPr/>
          </p:nvSpPr>
          <p:spPr>
            <a:xfrm>
              <a:off x="4020057" y="3669519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9" name="218 CuadroTexto"/>
            <p:cNvSpPr txBox="1"/>
            <p:nvPr/>
          </p:nvSpPr>
          <p:spPr>
            <a:xfrm>
              <a:off x="3961147" y="3652214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sp>
          <p:nvSpPr>
            <p:cNvPr id="220" name="219 Rectángulo"/>
            <p:cNvSpPr/>
            <p:nvPr/>
          </p:nvSpPr>
          <p:spPr>
            <a:xfrm>
              <a:off x="3502803" y="3669519"/>
              <a:ext cx="504000" cy="252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1" name="220 CuadroTexto"/>
            <p:cNvSpPr txBox="1"/>
            <p:nvPr/>
          </p:nvSpPr>
          <p:spPr>
            <a:xfrm>
              <a:off x="3462472" y="3662512"/>
              <a:ext cx="6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gRNA1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grpSp>
          <p:nvGrpSpPr>
            <p:cNvPr id="275" name="274 Grupo"/>
            <p:cNvGrpSpPr/>
            <p:nvPr/>
          </p:nvGrpSpPr>
          <p:grpSpPr>
            <a:xfrm>
              <a:off x="2434182" y="3680017"/>
              <a:ext cx="508234" cy="276999"/>
              <a:chOff x="2414841" y="3680017"/>
              <a:chExt cx="508234" cy="276999"/>
            </a:xfrm>
          </p:grpSpPr>
          <p:sp>
            <p:nvSpPr>
              <p:cNvPr id="193" name="192 Rectángulo"/>
              <p:cNvSpPr/>
              <p:nvPr/>
            </p:nvSpPr>
            <p:spPr>
              <a:xfrm>
                <a:off x="2490816" y="3683365"/>
                <a:ext cx="360000" cy="252000"/>
              </a:xfrm>
              <a:prstGeom prst="rect">
                <a:avLst/>
              </a:prstGeom>
              <a:pattFill prst="wdDnDiag">
                <a:fgClr>
                  <a:schemeClr val="bg1">
                    <a:lumMod val="65000"/>
                  </a:schemeClr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94" name="193 CuadroTexto"/>
              <p:cNvSpPr txBox="1"/>
              <p:nvPr/>
            </p:nvSpPr>
            <p:spPr>
              <a:xfrm>
                <a:off x="2414841" y="3680017"/>
                <a:ext cx="5082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b="1" dirty="0"/>
                  <a:t>attL5</a:t>
                </a:r>
                <a:endParaRPr lang="en-US" sz="1200" b="1" dirty="0"/>
              </a:p>
            </p:txBody>
          </p:sp>
        </p:grpSp>
        <p:cxnSp>
          <p:nvCxnSpPr>
            <p:cNvPr id="223" name="222 Conector recto"/>
            <p:cNvCxnSpPr/>
            <p:nvPr/>
          </p:nvCxnSpPr>
          <p:spPr>
            <a:xfrm>
              <a:off x="2924737" y="3670471"/>
              <a:ext cx="0" cy="25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223 CuadroTexto"/>
            <p:cNvSpPr txBox="1"/>
            <p:nvPr/>
          </p:nvSpPr>
          <p:spPr>
            <a:xfrm>
              <a:off x="2695863" y="3447223"/>
              <a:ext cx="800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/>
                <a:t>BsaI</a:t>
              </a:r>
              <a:endParaRPr lang="en-US" sz="1200" dirty="0"/>
            </a:p>
          </p:txBody>
        </p:sp>
        <p:pic>
          <p:nvPicPr>
            <p:cNvPr id="225" name="Picture 4" descr="C:\Users\mbundo\AppData\Local\Microsoft\Windows\Temporary Internet Files\Content.IE5\KU9IDDEE\scissors-silhouette[1]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2830068" y="3357147"/>
              <a:ext cx="186289" cy="1356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7" name="226 Flecha derecha"/>
            <p:cNvSpPr/>
            <p:nvPr/>
          </p:nvSpPr>
          <p:spPr>
            <a:xfrm>
              <a:off x="4262127" y="3573485"/>
              <a:ext cx="540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8" name="227 CuadroTexto"/>
            <p:cNvSpPr txBox="1"/>
            <p:nvPr/>
          </p:nvSpPr>
          <p:spPr>
            <a:xfrm>
              <a:off x="4251896" y="3665405"/>
              <a:ext cx="579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OsU3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29" name="228 Rectángulo"/>
            <p:cNvSpPr/>
            <p:nvPr/>
          </p:nvSpPr>
          <p:spPr>
            <a:xfrm>
              <a:off x="5321040" y="3673079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0" name="229 CuadroTexto"/>
            <p:cNvSpPr txBox="1"/>
            <p:nvPr/>
          </p:nvSpPr>
          <p:spPr>
            <a:xfrm>
              <a:off x="5266106" y="3655774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sp>
          <p:nvSpPr>
            <p:cNvPr id="231" name="230 Rectángulo"/>
            <p:cNvSpPr/>
            <p:nvPr/>
          </p:nvSpPr>
          <p:spPr>
            <a:xfrm>
              <a:off x="4807762" y="3673079"/>
              <a:ext cx="504000" cy="252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2" name="231 CuadroTexto"/>
            <p:cNvSpPr txBox="1"/>
            <p:nvPr/>
          </p:nvSpPr>
          <p:spPr>
            <a:xfrm>
              <a:off x="4771407" y="3666072"/>
              <a:ext cx="7453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gRNA2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33" name="232 Conector recto"/>
            <p:cNvCxnSpPr/>
            <p:nvPr/>
          </p:nvCxnSpPr>
          <p:spPr>
            <a:xfrm>
              <a:off x="5495409" y="3675422"/>
              <a:ext cx="0" cy="25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6" name="Picture 4" descr="C:\Users\mbundo\AppData\Local\Microsoft\Windows\Temporary Internet Files\Content.IE5\KU9IDDEE\scissors-silhouette[1]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5441431" y="3362624"/>
              <a:ext cx="180232" cy="1312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7" name="236 CuadroTexto"/>
            <p:cNvSpPr txBox="1"/>
            <p:nvPr/>
          </p:nvSpPr>
          <p:spPr>
            <a:xfrm>
              <a:off x="5292885" y="3448716"/>
              <a:ext cx="800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/>
                <a:t>BsaI</a:t>
              </a:r>
              <a:endParaRPr lang="en-US" sz="1200" dirty="0"/>
            </a:p>
          </p:txBody>
        </p:sp>
        <p:sp>
          <p:nvSpPr>
            <p:cNvPr id="238" name="237 Flecha derecha"/>
            <p:cNvSpPr/>
            <p:nvPr/>
          </p:nvSpPr>
          <p:spPr>
            <a:xfrm>
              <a:off x="3022101" y="5233073"/>
              <a:ext cx="540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9" name="238 CuadroTexto"/>
            <p:cNvSpPr txBox="1"/>
            <p:nvPr/>
          </p:nvSpPr>
          <p:spPr>
            <a:xfrm>
              <a:off x="3011870" y="5324993"/>
              <a:ext cx="579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OsU3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40" name="239 Rectángulo"/>
            <p:cNvSpPr/>
            <p:nvPr/>
          </p:nvSpPr>
          <p:spPr>
            <a:xfrm>
              <a:off x="4077038" y="5332667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1" name="240 CuadroTexto"/>
            <p:cNvSpPr txBox="1"/>
            <p:nvPr/>
          </p:nvSpPr>
          <p:spPr>
            <a:xfrm>
              <a:off x="4018128" y="5315362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sp>
          <p:nvSpPr>
            <p:cNvPr id="242" name="241 Rectángulo"/>
            <p:cNvSpPr/>
            <p:nvPr/>
          </p:nvSpPr>
          <p:spPr>
            <a:xfrm>
              <a:off x="3559784" y="5332667"/>
              <a:ext cx="504000" cy="252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3" name="242 CuadroTexto"/>
            <p:cNvSpPr txBox="1"/>
            <p:nvPr/>
          </p:nvSpPr>
          <p:spPr>
            <a:xfrm>
              <a:off x="3519453" y="5325660"/>
              <a:ext cx="6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gRNA1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47" name="246 Flecha derecha"/>
            <p:cNvSpPr/>
            <p:nvPr/>
          </p:nvSpPr>
          <p:spPr>
            <a:xfrm>
              <a:off x="4319108" y="5236633"/>
              <a:ext cx="540000" cy="461665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8" name="247 CuadroTexto"/>
            <p:cNvSpPr txBox="1"/>
            <p:nvPr/>
          </p:nvSpPr>
          <p:spPr>
            <a:xfrm>
              <a:off x="4308877" y="5328553"/>
              <a:ext cx="5797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OsU3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49" name="248 Rectángulo"/>
            <p:cNvSpPr/>
            <p:nvPr/>
          </p:nvSpPr>
          <p:spPr>
            <a:xfrm>
              <a:off x="5378021" y="5336227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0" name="249 CuadroTexto"/>
            <p:cNvSpPr txBox="1"/>
            <p:nvPr/>
          </p:nvSpPr>
          <p:spPr>
            <a:xfrm>
              <a:off x="5323087" y="5318922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  <p:sp>
          <p:nvSpPr>
            <p:cNvPr id="251" name="250 Rectángulo"/>
            <p:cNvSpPr/>
            <p:nvPr/>
          </p:nvSpPr>
          <p:spPr>
            <a:xfrm>
              <a:off x="4864743" y="5336227"/>
              <a:ext cx="504000" cy="252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2" name="251 CuadroTexto"/>
            <p:cNvSpPr txBox="1"/>
            <p:nvPr/>
          </p:nvSpPr>
          <p:spPr>
            <a:xfrm>
              <a:off x="4828388" y="5329220"/>
              <a:ext cx="7453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>
                  <a:solidFill>
                    <a:schemeClr val="bg1"/>
                  </a:solidFill>
                </a:rPr>
                <a:t>gRNA2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57" name="256 Rectángulo"/>
            <p:cNvSpPr/>
            <p:nvPr/>
          </p:nvSpPr>
          <p:spPr>
            <a:xfrm>
              <a:off x="1943092" y="5303217"/>
              <a:ext cx="396000" cy="2520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8" name="257 CuadroTexto"/>
            <p:cNvSpPr txBox="1"/>
            <p:nvPr/>
          </p:nvSpPr>
          <p:spPr>
            <a:xfrm>
              <a:off x="1917215" y="5292786"/>
              <a:ext cx="7453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Cas9</a:t>
              </a:r>
              <a:endParaRPr lang="en-US" sz="1200" b="1" dirty="0"/>
            </a:p>
          </p:txBody>
        </p:sp>
        <p:sp>
          <p:nvSpPr>
            <p:cNvPr id="259" name="258 Rectángulo"/>
            <p:cNvSpPr/>
            <p:nvPr/>
          </p:nvSpPr>
          <p:spPr>
            <a:xfrm>
              <a:off x="2352059" y="5301330"/>
              <a:ext cx="144000" cy="2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0" name="259 CuadroTexto"/>
            <p:cNvSpPr txBox="1"/>
            <p:nvPr/>
          </p:nvSpPr>
          <p:spPr>
            <a:xfrm>
              <a:off x="2296118" y="5280191"/>
              <a:ext cx="296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b="1" dirty="0"/>
                <a:t>T</a:t>
              </a:r>
              <a:endParaRPr lang="en-US" sz="1200" b="1" dirty="0"/>
            </a:p>
          </p:txBody>
        </p: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7DC64AEE-B82E-6A0B-2D24-9A39E9023E51}"/>
              </a:ext>
            </a:extLst>
          </p:cNvPr>
          <p:cNvSpPr txBox="1"/>
          <p:nvPr/>
        </p:nvSpPr>
        <p:spPr>
          <a:xfrm>
            <a:off x="3030693" y="8856170"/>
            <a:ext cx="272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  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38BD1B34-C427-AE90-8832-E21B09D860FF}"/>
              </a:ext>
            </a:extLst>
          </p:cNvPr>
          <p:cNvSpPr txBox="1"/>
          <p:nvPr/>
        </p:nvSpPr>
        <p:spPr>
          <a:xfrm>
            <a:off x="943404" y="8721090"/>
            <a:ext cx="51776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ategy followed for construction of the plasmid used for CRISPR/Cas9-based genome editing of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827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rice. The sgRNA1 and sgRNA2 were introduced into vectors pYPQ131D and pYPQ132D, respectively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wde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t al., </a:t>
            </a:r>
            <a:r>
              <a:rPr lang="en-US" sz="1200" kern="100" dirty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15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U3, </a:t>
            </a:r>
            <a:r>
              <a:rPr lang="fr-FR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ce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3 RNA </a:t>
            </a:r>
            <a:r>
              <a:rPr lang="fr-FR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lymerase</a:t>
            </a:r>
            <a:r>
              <a:rPr lang="fr-FR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moter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fr-FR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mUbi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fr-FR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ize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biquitin</a:t>
            </a:r>
            <a:r>
              <a:rPr lang="fr-FR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moter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T, transcription </a:t>
            </a:r>
            <a:r>
              <a:rPr lang="fr-FR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rminator</a:t>
            </a:r>
            <a:r>
              <a:rPr lang="fr-FR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"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t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" indicates gateway recombination sites. </a:t>
            </a:r>
            <a:endParaRPr lang="es-E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3</TotalTime>
  <Words>147</Words>
  <Application>Microsoft Office PowerPoint</Application>
  <PresentationFormat>Panorámica</PresentationFormat>
  <Paragraphs>5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ahoma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lanca San Segundo de los Mozos</dc:creator>
  <cp:lastModifiedBy>Blanca San Segundo de los Mozos</cp:lastModifiedBy>
  <cp:revision>45</cp:revision>
  <cp:lastPrinted>2022-08-26T16:40:22Z</cp:lastPrinted>
  <dcterms:created xsi:type="dcterms:W3CDTF">2022-08-14T09:50:05Z</dcterms:created>
  <dcterms:modified xsi:type="dcterms:W3CDTF">2024-07-02T11:02:02Z</dcterms:modified>
</cp:coreProperties>
</file>